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85415-9F8E-48B8-B97D-A3A48D04B4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140D1-900D-41D0-8EE9-E76A23D3C1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EA40A-AFFF-4E32-9CC9-D4BBE3724F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EE432-874A-4807-BAF8-1DA6F5392A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BA0E95-3E53-4267-8DA0-94B973E2A0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3B6C29-D22A-42B1-BBDD-B5CB33795F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4012C-085A-4878-A3D8-A4A49463EE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A0279-A2D2-4816-BB97-D7A4C29338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C69A6-6942-42A6-852E-A0FB727FEE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C52BA-200C-4B8D-9AB4-F22249AE83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2B251-4107-4F27-BE0C-604B4BCC30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E06DF8-615F-425B-8ABF-D88AA9DBD5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2AAB7A-8F2F-4414-9ACF-89381586ED4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hylogenetic tree showing divergence times and the evolution of gene family siz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971800" y="1600200"/>
            <a:ext cx="3200400" cy="36878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-Q Zha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1–5 (2017) doi:10.1038/nature2389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1T09:52:34Z</dcterms:created>
  <dc:creator>ravikumar.n</dc:creator>
  <dc:description/>
  <dc:language>en-US</dc:language>
  <cp:lastModifiedBy>ravikumar.n</cp:lastModifiedBy>
  <dcterms:modified xsi:type="dcterms:W3CDTF">2017-09-11T09:52:37Z</dcterms:modified>
  <cp:revision>1</cp:revision>
  <dc:subject/>
  <dc:title>Phylogenetic tree showing divergence times and the evolution of gene family sizes</dc:title>
</cp:coreProperties>
</file>